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349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lomka, Marek" userId="b5697613-81d3-4318-a926-46b10f876ab5" providerId="ADAL" clId="{CC35ED90-A2B0-4996-87CF-07233DB330B5}"/>
    <pc:docChg chg="modSld">
      <pc:chgData name="Slomka, Marek" userId="b5697613-81d3-4318-a926-46b10f876ab5" providerId="ADAL" clId="{CC35ED90-A2B0-4996-87CF-07233DB330B5}" dt="2023-04-17T12:22:26.509" v="6" actId="20577"/>
      <pc:docMkLst>
        <pc:docMk/>
      </pc:docMkLst>
      <pc:sldChg chg="modSp mod">
        <pc:chgData name="Slomka, Marek" userId="b5697613-81d3-4318-a926-46b10f876ab5" providerId="ADAL" clId="{CC35ED90-A2B0-4996-87CF-07233DB330B5}" dt="2023-04-17T12:22:26.509" v="6" actId="20577"/>
        <pc:sldMkLst>
          <pc:docMk/>
          <pc:sldMk cId="2482702820" sldId="258"/>
        </pc:sldMkLst>
        <pc:spChg chg="mod">
          <ac:chgData name="Slomka, Marek" userId="b5697613-81d3-4318-a926-46b10f876ab5" providerId="ADAL" clId="{CC35ED90-A2B0-4996-87CF-07233DB330B5}" dt="2023-04-17T12:22:26.509" v="6" actId="20577"/>
          <ac:spMkLst>
            <pc:docMk/>
            <pc:sldMk cId="2482702820" sldId="258"/>
            <ac:spMk id="12" creationId="{72FE6F71-4D71-4980-80F4-97108733D47F}"/>
          </ac:spMkLst>
        </pc:spChg>
      </pc:sldChg>
    </pc:docChg>
  </pc:docChgLst>
  <pc:docChgLst>
    <pc:chgData name="Slomka, Marek" userId="b5697613-81d3-4318-a926-46b10f876ab5" providerId="ADAL" clId="{2E773390-B1C3-40D5-BC9A-071F51813290}"/>
    <pc:docChg chg="modSld">
      <pc:chgData name="Slomka, Marek" userId="b5697613-81d3-4318-a926-46b10f876ab5" providerId="ADAL" clId="{2E773390-B1C3-40D5-BC9A-071F51813290}" dt="2022-09-20T11:13:06.525" v="26" actId="1036"/>
      <pc:docMkLst>
        <pc:docMk/>
      </pc:docMkLst>
      <pc:sldChg chg="addSp modSp mod">
        <pc:chgData name="Slomka, Marek" userId="b5697613-81d3-4318-a926-46b10f876ab5" providerId="ADAL" clId="{2E773390-B1C3-40D5-BC9A-071F51813290}" dt="2022-09-20T11:13:06.525" v="26" actId="1036"/>
        <pc:sldMkLst>
          <pc:docMk/>
          <pc:sldMk cId="2482702820" sldId="258"/>
        </pc:sldMkLst>
        <pc:spChg chg="add mod">
          <ac:chgData name="Slomka, Marek" userId="b5697613-81d3-4318-a926-46b10f876ab5" providerId="ADAL" clId="{2E773390-B1C3-40D5-BC9A-071F51813290}" dt="2022-09-20T11:13:06.525" v="26" actId="1036"/>
          <ac:spMkLst>
            <pc:docMk/>
            <pc:sldMk cId="2482702820" sldId="258"/>
            <ac:spMk id="12" creationId="{72FE6F71-4D71-4980-80F4-97108733D47F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C85FCF-32E4-4982-BEB5-22E1350562C2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E91B8-2647-4655-A0AD-0EC1AA571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8585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C85FCF-32E4-4982-BEB5-22E1350562C2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E91B8-2647-4655-A0AD-0EC1AA571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88531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C85FCF-32E4-4982-BEB5-22E1350562C2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E91B8-2647-4655-A0AD-0EC1AA571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55822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C85FCF-32E4-4982-BEB5-22E1350562C2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E91B8-2647-4655-A0AD-0EC1AA571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86652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C85FCF-32E4-4982-BEB5-22E1350562C2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E91B8-2647-4655-A0AD-0EC1AA571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82896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C85FCF-32E4-4982-BEB5-22E1350562C2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E91B8-2647-4655-A0AD-0EC1AA571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8349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C85FCF-32E4-4982-BEB5-22E1350562C2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E91B8-2647-4655-A0AD-0EC1AA571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81814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C85FCF-32E4-4982-BEB5-22E1350562C2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E91B8-2647-4655-A0AD-0EC1AA571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44533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C85FCF-32E4-4982-BEB5-22E1350562C2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E91B8-2647-4655-A0AD-0EC1AA571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5915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C85FCF-32E4-4982-BEB5-22E1350562C2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E91B8-2647-4655-A0AD-0EC1AA571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88855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C85FCF-32E4-4982-BEB5-22E1350562C2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E91B8-2647-4655-A0AD-0EC1AA571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78530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C85FCF-32E4-4982-BEB5-22E1350562C2}" type="datetimeFigureOut">
              <a:rPr lang="en-GB" smtClean="0"/>
              <a:t>17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9E91B8-2647-4655-A0AD-0EC1AA57187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97012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35521E53-D57E-4DF5-9F6B-9070905BCFF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60114382"/>
              </p:ext>
            </p:extLst>
          </p:nvPr>
        </p:nvGraphicFramePr>
        <p:xfrm>
          <a:off x="152400" y="1913464"/>
          <a:ext cx="6531559" cy="7823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7061901" imgH="8459308" progId="Prism8.Document">
                  <p:embed/>
                </p:oleObj>
              </mc:Choice>
              <mc:Fallback>
                <p:oleObj name="Prism 8" r:id="rId2" imgW="7061901" imgH="8459308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35521E53-D57E-4DF5-9F6B-9070905BCFF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52400" y="1913464"/>
                        <a:ext cx="6531559" cy="7823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EFE64C57-7574-4E8F-A617-AB12A1E75EBC}"/>
              </a:ext>
            </a:extLst>
          </p:cNvPr>
          <p:cNvSpPr txBox="1"/>
          <p:nvPr/>
        </p:nvSpPr>
        <p:spPr>
          <a:xfrm>
            <a:off x="-66730" y="1999277"/>
            <a:ext cx="22960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200" dirty="0"/>
              <a:t>          a) n=22; 22/22 infected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53F47C0-3E46-4126-B44C-6CA01DB9B698}"/>
              </a:ext>
            </a:extLst>
          </p:cNvPr>
          <p:cNvSpPr txBox="1"/>
          <p:nvPr/>
        </p:nvSpPr>
        <p:spPr>
          <a:xfrm>
            <a:off x="2316922" y="1999277"/>
            <a:ext cx="215057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200" dirty="0"/>
              <a:t>   b) n=22; 22/22 infected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911B3C9-D427-4334-9FB8-E82C33E81D18}"/>
              </a:ext>
            </a:extLst>
          </p:cNvPr>
          <p:cNvSpPr txBox="1"/>
          <p:nvPr/>
        </p:nvSpPr>
        <p:spPr>
          <a:xfrm>
            <a:off x="4260990" y="1988673"/>
            <a:ext cx="22960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200" dirty="0"/>
              <a:t>         c) n=22; 22/22 infecte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72E50B3-FEBE-41F0-9C88-C5530C4BE36C}"/>
              </a:ext>
            </a:extLst>
          </p:cNvPr>
          <p:cNvSpPr txBox="1"/>
          <p:nvPr/>
        </p:nvSpPr>
        <p:spPr>
          <a:xfrm>
            <a:off x="-182518" y="4832452"/>
            <a:ext cx="239493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200" dirty="0"/>
              <a:t>             d) n=22; 22/22 infecte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BE6CE64-BA9E-4E96-85A1-B3D46C6AFE39}"/>
              </a:ext>
            </a:extLst>
          </p:cNvPr>
          <p:cNvSpPr txBox="1"/>
          <p:nvPr/>
        </p:nvSpPr>
        <p:spPr>
          <a:xfrm>
            <a:off x="1926997" y="4845879"/>
            <a:ext cx="288814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200" dirty="0"/>
              <a:t>              e) n=20; 19/20 infected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8DF540C-5F1C-488C-BC8D-9E55D105C0AE}"/>
              </a:ext>
            </a:extLst>
          </p:cNvPr>
          <p:cNvSpPr txBox="1"/>
          <p:nvPr/>
        </p:nvSpPr>
        <p:spPr>
          <a:xfrm>
            <a:off x="4172592" y="4837415"/>
            <a:ext cx="308907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200" dirty="0"/>
              <a:t>            f) n=22; 22/22 infected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95A8592-0972-46E9-8CC0-AC0AD6EE0463}"/>
              </a:ext>
            </a:extLst>
          </p:cNvPr>
          <p:cNvSpPr txBox="1"/>
          <p:nvPr/>
        </p:nvSpPr>
        <p:spPr>
          <a:xfrm>
            <a:off x="182076" y="7678743"/>
            <a:ext cx="239493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200" dirty="0"/>
              <a:t>   g) n=22; 22/22 infected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380E94B-1B3A-4FD8-9E5B-DE42CAD3EA3B}"/>
              </a:ext>
            </a:extLst>
          </p:cNvPr>
          <p:cNvSpPr txBox="1"/>
          <p:nvPr/>
        </p:nvSpPr>
        <p:spPr>
          <a:xfrm>
            <a:off x="2309998" y="7681951"/>
            <a:ext cx="221845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200" dirty="0"/>
              <a:t>   h) n=22; 21/22 infected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279934C-5B5F-4947-81AC-32B5223B5B94}"/>
              </a:ext>
            </a:extLst>
          </p:cNvPr>
          <p:cNvSpPr txBox="1"/>
          <p:nvPr/>
        </p:nvSpPr>
        <p:spPr>
          <a:xfrm>
            <a:off x="4484915" y="7676450"/>
            <a:ext cx="211830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200" dirty="0"/>
              <a:t>   </a:t>
            </a:r>
            <a:r>
              <a:rPr lang="en-GB" sz="1200" dirty="0" err="1"/>
              <a:t>i</a:t>
            </a:r>
            <a:r>
              <a:rPr lang="en-GB" sz="1200" dirty="0"/>
              <a:t>) n=20; 20/20 infected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2FE6F71-4D71-4980-80F4-97108733D47F}"/>
              </a:ext>
            </a:extLst>
          </p:cNvPr>
          <p:cNvSpPr txBox="1"/>
          <p:nvPr/>
        </p:nvSpPr>
        <p:spPr>
          <a:xfrm>
            <a:off x="55076" y="9564557"/>
            <a:ext cx="667592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:  </a:t>
            </a:r>
            <a:r>
              <a:rPr lang="en-GB" sz="14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stribution of Ct values as a measure OP and C shedding at nine subsequent commercial turkey IPs identified between December 2021 and February 2022.  Panels (a) to (</a:t>
            </a:r>
            <a:r>
              <a:rPr lang="en-GB" sz="14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GB" sz="14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show the Ct values for the turkey IPs 16, 18, 28, 29, 30, 31, 32, 33 and 35 respectively (Table 1).  </a:t>
            </a:r>
            <a:r>
              <a:rPr lang="en-GB" sz="140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e Figure </a:t>
            </a:r>
            <a:r>
              <a:rPr lang="en-GB" sz="14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2 legend for other details.</a:t>
            </a:r>
            <a:r>
              <a:rPr lang="en-GB" sz="1400" b="1" i="1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en-GB" sz="14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27028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</TotalTime>
  <Words>155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8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lomka, Marek</dc:creator>
  <cp:lastModifiedBy>Slomka, Marek</cp:lastModifiedBy>
  <cp:revision>7</cp:revision>
  <dcterms:created xsi:type="dcterms:W3CDTF">2022-04-08T17:49:11Z</dcterms:created>
  <dcterms:modified xsi:type="dcterms:W3CDTF">2023-04-17T12:22:31Z</dcterms:modified>
</cp:coreProperties>
</file>